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9" r:id="rId3"/>
    <p:sldId id="262" r:id="rId4"/>
    <p:sldId id="264" r:id="rId5"/>
    <p:sldId id="263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6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51"/>
  </p:normalViewPr>
  <p:slideViewPr>
    <p:cSldViewPr snapToGrid="0" showGuides="1">
      <p:cViewPr varScale="1">
        <p:scale>
          <a:sx n="105" d="100"/>
          <a:sy n="105" d="100"/>
        </p:scale>
        <p:origin x="840" y="192"/>
      </p:cViewPr>
      <p:guideLst>
        <p:guide orient="horz" pos="2160"/>
        <p:guide pos="386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F011817-98FE-03AC-A360-3B85E75A8AA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614125AC-AF42-7976-9103-2F8F11B15AC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E346EB8-C58D-E852-00F5-4F97891847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3BC17-1608-FD44-9304-75C118F81ED7}" type="datetimeFigureOut">
              <a:rPr kumimoji="1" lang="zh-CN" altLang="en-US" smtClean="0"/>
              <a:t>2024/1/29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C65E1DA-4267-B031-CA5E-7956A650D5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CE30BD7-F7E9-C5E0-BBB2-723A4FD3E7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458B6-3FD5-1842-8165-4BF813242A5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1551392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B6DADC4-65F4-A769-3590-502C9FB263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2E89938-B0FA-9A3D-3A3D-06ADA7C3BF8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991401D-40E5-7760-F5A1-936BD1E729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3BC17-1608-FD44-9304-75C118F81ED7}" type="datetimeFigureOut">
              <a:rPr kumimoji="1" lang="zh-CN" altLang="en-US" smtClean="0"/>
              <a:t>2024/1/29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3081331-4A95-AA70-6AEA-51BD3A9CA4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AC03DF3-4322-A36C-44CD-5D5DA45098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458B6-3FD5-1842-8165-4BF813242A5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872699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7EAD21C0-45D6-CC0C-B02F-2DE504402A3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749EFBD-70E5-72BC-4A9B-E717A32662F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F5429AD-CBFC-6EE8-B80B-559A2D2F94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3BC17-1608-FD44-9304-75C118F81ED7}" type="datetimeFigureOut">
              <a:rPr kumimoji="1" lang="zh-CN" altLang="en-US" smtClean="0"/>
              <a:t>2024/1/29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9785544-495C-F799-F648-7831346580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9EBD4EC-5040-0198-A82D-39B77DB202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458B6-3FD5-1842-8165-4BF813242A5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4684645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A87CA3E-85CA-67E8-9DE3-221209856B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F4FC9B8-7A2E-1B0F-F083-F6441B03523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2D95DD4-D9C6-5E76-252A-37BBE28D0E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3BC17-1608-FD44-9304-75C118F81ED7}" type="datetimeFigureOut">
              <a:rPr kumimoji="1" lang="zh-CN" altLang="en-US" smtClean="0"/>
              <a:t>2024/1/29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E538534-9A42-FC6F-B86C-4565DF5CF0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2C04C99-07E2-4399-D4DB-80FF9C97EF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458B6-3FD5-1842-8165-4BF813242A5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206165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6267D92-F30B-1CE5-9983-9718658E50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9D48D5D-09DF-4E71-D96D-03F6790E25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E5569A2-867E-0DA1-57A8-1D33FF51DA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3BC17-1608-FD44-9304-75C118F81ED7}" type="datetimeFigureOut">
              <a:rPr kumimoji="1" lang="zh-CN" altLang="en-US" smtClean="0"/>
              <a:t>2024/1/29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7A2DE16-D345-94A3-B775-55EC8D6FB6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82D8902-291E-0BBB-A6FC-111A596B18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458B6-3FD5-1842-8165-4BF813242A5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927678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E257789-9AFE-614E-B124-FF7D4961DD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1D122E6-9D54-7EBA-253E-D91A075434A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A6BE096-DE8D-BD41-999C-56E7D8137D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BF322D5-9737-B788-5FCC-6CCE73B1B5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3BC17-1608-FD44-9304-75C118F81ED7}" type="datetimeFigureOut">
              <a:rPr kumimoji="1" lang="zh-CN" altLang="en-US" smtClean="0"/>
              <a:t>2024/1/29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3211CBE-4E1D-73A0-DFA4-15B0C01CD4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AAC7EC6-03F0-5D19-3504-C2FADAE173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458B6-3FD5-1842-8165-4BF813242A5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6534787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036022B-3C26-B19B-F6F4-0DD7EF9CFB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3FEE3FB-6FA7-AA77-7F23-59ED68A0B9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FEA39E6-488D-E948-4DA8-51C8A6F981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AC80D4B6-852F-B666-E316-B68853A5A9B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957EE179-5997-1472-9CC0-2D6B71FCC32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43C5D3C-2722-2602-CD53-96B1A5E818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3BC17-1608-FD44-9304-75C118F81ED7}" type="datetimeFigureOut">
              <a:rPr kumimoji="1" lang="zh-CN" altLang="en-US" smtClean="0"/>
              <a:t>2024/1/29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EC8875FC-4979-688C-8ABF-C8D432D96D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BC6730AF-304D-C4AC-F5AB-B68F3DD80A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458B6-3FD5-1842-8165-4BF813242A5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7740315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16BEEA8-EC6A-EACF-132C-247F63EDDD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7117A5AA-CD74-BAC2-3101-FEB531D93B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3BC17-1608-FD44-9304-75C118F81ED7}" type="datetimeFigureOut">
              <a:rPr kumimoji="1" lang="zh-CN" altLang="en-US" smtClean="0"/>
              <a:t>2024/1/29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5141A4DA-116C-0388-8DD9-06D5BF624F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98DA74D3-9DDA-9669-E14E-3E7377A6DB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458B6-3FD5-1842-8165-4BF813242A5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7442434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48D951F6-979F-065B-176B-C7D2B1699B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3BC17-1608-FD44-9304-75C118F81ED7}" type="datetimeFigureOut">
              <a:rPr kumimoji="1" lang="zh-CN" altLang="en-US" smtClean="0"/>
              <a:t>2024/1/29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6807DD5F-3419-A1AC-C87F-E495A14D37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99B178F0-96C5-8347-C636-FBE1AAFE33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458B6-3FD5-1842-8165-4BF813242A5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4446803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7C2E10A-4344-5462-C832-3B92306960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9AE868D-5AE3-F2AF-2A45-3C943913580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541851F-E6E1-E149-CFA6-EE29B76C658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2CC35A2-288E-8FB9-1B67-84558F946A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3BC17-1608-FD44-9304-75C118F81ED7}" type="datetimeFigureOut">
              <a:rPr kumimoji="1" lang="zh-CN" altLang="en-US" smtClean="0"/>
              <a:t>2024/1/29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BBB2DC5-A8BE-C3B4-0C1B-C62E2DE219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C6B8396-D39D-E314-9CD1-3EFE7EF536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458B6-3FD5-1842-8165-4BF813242A5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4717806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58F42C2-EECC-050B-0776-FC834C57C9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F97512FC-CCA3-03ED-11F3-8D234D5DBD0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5E29325-B330-AB6B-080C-06B8AD768B2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5E117A3-0D9C-2A41-3264-4335026404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3BC17-1608-FD44-9304-75C118F81ED7}" type="datetimeFigureOut">
              <a:rPr kumimoji="1" lang="zh-CN" altLang="en-US" smtClean="0"/>
              <a:t>2024/1/29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9EB688D-E3A8-B931-6536-77838798E8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83A31F1-9F72-D71F-8E31-44D589C96C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458B6-3FD5-1842-8165-4BF813242A5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7296258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70A09F04-4A4E-8FBE-4B04-E47A2B3DBE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333091F-84C9-6C84-DC95-2467910310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AA5BBB6-9060-F7ED-5EAF-2232767E50B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A3BC17-1608-FD44-9304-75C118F81ED7}" type="datetimeFigureOut">
              <a:rPr kumimoji="1" lang="zh-CN" altLang="en-US" smtClean="0"/>
              <a:t>2024/1/29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5F888DE-836D-A990-AEE6-9386B7FC4F5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65766ED-2D29-7718-15B0-FC7046824A6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1458B6-3FD5-1842-8165-4BF813242A5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8956932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7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0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"/><Relationship Id="rId2" Type="http://schemas.openxmlformats.org/officeDocument/2006/relationships/image" Target="../media/image1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2F99CAF7-6344-3A0E-DABE-DA20DC996B6F}"/>
              </a:ext>
            </a:extLst>
          </p:cNvPr>
          <p:cNvSpPr txBox="1"/>
          <p:nvPr/>
        </p:nvSpPr>
        <p:spPr>
          <a:xfrm>
            <a:off x="300624" y="150312"/>
            <a:ext cx="34483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" altLang="zh-CN" b="1" dirty="0"/>
              <a:t>Full unedited blot for Figure 1E</a:t>
            </a:r>
            <a:endParaRPr kumimoji="1"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B90AB27B-41F5-8378-7DCC-0CD2955E54F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31102" y="1556816"/>
            <a:ext cx="5006235" cy="4029409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9C6E7D25-F692-454A-CAE7-BFA84BB6AC5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12280" y="1556815"/>
            <a:ext cx="5006236" cy="4029410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7B0B83D0-E29D-7DF6-4129-93A02F4B1B84}"/>
              </a:ext>
            </a:extLst>
          </p:cNvPr>
          <p:cNvSpPr txBox="1"/>
          <p:nvPr/>
        </p:nvSpPr>
        <p:spPr>
          <a:xfrm>
            <a:off x="931102" y="1087109"/>
            <a:ext cx="1072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800" kern="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C/EBPα</a:t>
            </a:r>
            <a:r>
              <a:rPr lang="zh-CN" altLang="zh-CN" dirty="0">
                <a:effectLst/>
              </a:rPr>
              <a:t> 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1609ED47-ABF8-885A-EC3E-1B788FC403BC}"/>
              </a:ext>
            </a:extLst>
          </p:cNvPr>
          <p:cNvSpPr txBox="1"/>
          <p:nvPr/>
        </p:nvSpPr>
        <p:spPr>
          <a:xfrm>
            <a:off x="6437000" y="1087109"/>
            <a:ext cx="1213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800" kern="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α-Tubulin</a:t>
            </a:r>
            <a:r>
              <a:rPr lang="zh-CN" altLang="zh-CN" dirty="0">
                <a:effectLst/>
              </a:rPr>
              <a:t> 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328622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2F99CAF7-6344-3A0E-DABE-DA20DC996B6F}"/>
              </a:ext>
            </a:extLst>
          </p:cNvPr>
          <p:cNvSpPr txBox="1"/>
          <p:nvPr/>
        </p:nvSpPr>
        <p:spPr>
          <a:xfrm>
            <a:off x="300624" y="150312"/>
            <a:ext cx="34483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" altLang="zh-CN" b="1" dirty="0"/>
              <a:t>Full unedited blot for Figure 3C</a:t>
            </a:r>
            <a:endParaRPr kumimoji="1"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7B0B83D0-E29D-7DF6-4129-93A02F4B1B84}"/>
              </a:ext>
            </a:extLst>
          </p:cNvPr>
          <p:cNvSpPr txBox="1"/>
          <p:nvPr/>
        </p:nvSpPr>
        <p:spPr>
          <a:xfrm>
            <a:off x="931102" y="1087109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800" kern="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GPX4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内容占位符 4">
            <a:extLst>
              <a:ext uri="{FF2B5EF4-FFF2-40B4-BE49-F238E27FC236}">
                <a16:creationId xmlns:a16="http://schemas.microsoft.com/office/drawing/2014/main" id="{7290A001-8351-FC55-D435-D2816040063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6000" y="1511360"/>
            <a:ext cx="4432996" cy="3568021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A258C629-5D92-9F90-8DD7-EBF9AFFECAB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31102" y="1511360"/>
            <a:ext cx="4765044" cy="3835279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C53A5000-F1E0-886C-6659-4DAF542B6585}"/>
              </a:ext>
            </a:extLst>
          </p:cNvPr>
          <p:cNvSpPr txBox="1"/>
          <p:nvPr/>
        </p:nvSpPr>
        <p:spPr>
          <a:xfrm>
            <a:off x="6730259" y="1142028"/>
            <a:ext cx="9076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800" kern="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β-Actin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62698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2F99CAF7-6344-3A0E-DABE-DA20DC996B6F}"/>
              </a:ext>
            </a:extLst>
          </p:cNvPr>
          <p:cNvSpPr txBox="1"/>
          <p:nvPr/>
        </p:nvSpPr>
        <p:spPr>
          <a:xfrm>
            <a:off x="300624" y="150312"/>
            <a:ext cx="34884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" altLang="zh-CN" b="1" dirty="0"/>
              <a:t>Full unedited blot for Figure 5G</a:t>
            </a:r>
            <a:endParaRPr kumimoji="1"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" name="组合 15">
            <a:extLst>
              <a:ext uri="{FF2B5EF4-FFF2-40B4-BE49-F238E27FC236}">
                <a16:creationId xmlns:a16="http://schemas.microsoft.com/office/drawing/2014/main" id="{EF63EC53-CCA9-1A68-4A10-0279DC02E750}"/>
              </a:ext>
            </a:extLst>
          </p:cNvPr>
          <p:cNvGrpSpPr/>
          <p:nvPr/>
        </p:nvGrpSpPr>
        <p:grpSpPr>
          <a:xfrm>
            <a:off x="300624" y="1825773"/>
            <a:ext cx="5201743" cy="4232474"/>
            <a:chOff x="300624" y="1825773"/>
            <a:chExt cx="5201743" cy="4232474"/>
          </a:xfrm>
        </p:grpSpPr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2E75B7E2-B7B7-EEB5-7223-9B311656363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00624" y="1825773"/>
              <a:ext cx="5201743" cy="4232474"/>
            </a:xfrm>
            <a:prstGeom prst="rect">
              <a:avLst/>
            </a:prstGeom>
          </p:spPr>
        </p:pic>
        <p:sp>
          <p:nvSpPr>
            <p:cNvPr id="13" name="框架 12">
              <a:extLst>
                <a:ext uri="{FF2B5EF4-FFF2-40B4-BE49-F238E27FC236}">
                  <a16:creationId xmlns:a16="http://schemas.microsoft.com/office/drawing/2014/main" id="{34027D49-7F79-4287-65C4-E0C2C0DC7683}"/>
                </a:ext>
              </a:extLst>
            </p:cNvPr>
            <p:cNvSpPr/>
            <p:nvPr/>
          </p:nvSpPr>
          <p:spPr>
            <a:xfrm>
              <a:off x="429811" y="3106364"/>
              <a:ext cx="4484318" cy="554369"/>
            </a:xfrm>
            <a:prstGeom prst="fram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>
                <a:solidFill>
                  <a:schemeClr val="tx1"/>
                </a:solidFill>
              </a:endParaRPr>
            </a:p>
          </p:txBody>
        </p:sp>
      </p:grpSp>
      <p:sp>
        <p:nvSpPr>
          <p:cNvPr id="14" name="文本框 13">
            <a:extLst>
              <a:ext uri="{FF2B5EF4-FFF2-40B4-BE49-F238E27FC236}">
                <a16:creationId xmlns:a16="http://schemas.microsoft.com/office/drawing/2014/main" id="{9AC48AC9-04AC-60E9-3C31-92FB3E0B4049}"/>
              </a:ext>
            </a:extLst>
          </p:cNvPr>
          <p:cNvSpPr txBox="1"/>
          <p:nvPr/>
        </p:nvSpPr>
        <p:spPr>
          <a:xfrm>
            <a:off x="337700" y="1456441"/>
            <a:ext cx="13260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800" kern="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Fibronectin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" name="组合 16">
            <a:extLst>
              <a:ext uri="{FF2B5EF4-FFF2-40B4-BE49-F238E27FC236}">
                <a16:creationId xmlns:a16="http://schemas.microsoft.com/office/drawing/2014/main" id="{F53DEEED-C1E9-F190-58DF-48B1C2F4C6F8}"/>
              </a:ext>
            </a:extLst>
          </p:cNvPr>
          <p:cNvGrpSpPr/>
          <p:nvPr/>
        </p:nvGrpSpPr>
        <p:grpSpPr>
          <a:xfrm>
            <a:off x="6408585" y="-34185"/>
            <a:ext cx="5018238" cy="3435447"/>
            <a:chOff x="6408585" y="-34185"/>
            <a:chExt cx="5018238" cy="3435447"/>
          </a:xfrm>
        </p:grpSpPr>
        <p:pic>
          <p:nvPicPr>
            <p:cNvPr id="10" name="图片 9">
              <a:extLst>
                <a:ext uri="{FF2B5EF4-FFF2-40B4-BE49-F238E27FC236}">
                  <a16:creationId xmlns:a16="http://schemas.microsoft.com/office/drawing/2014/main" id="{02E5A02D-19ED-742B-E4E6-ED2CE66FA0D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689635" y="311022"/>
              <a:ext cx="4737188" cy="3090240"/>
            </a:xfrm>
            <a:prstGeom prst="rect">
              <a:avLst/>
            </a:prstGeom>
          </p:spPr>
        </p:pic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6E8D3D80-B150-5763-C9BB-30B9F1B38ABA}"/>
                </a:ext>
              </a:extLst>
            </p:cNvPr>
            <p:cNvSpPr txBox="1"/>
            <p:nvPr/>
          </p:nvSpPr>
          <p:spPr>
            <a:xfrm>
              <a:off x="6408585" y="-34185"/>
              <a:ext cx="12137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800" kern="0" dirty="0">
                  <a:effectLst/>
                  <a:latin typeface="Arial" panose="020B0604020202020204" pitchFamily="34" charset="0"/>
                  <a:ea typeface="宋体" panose="02010600030101010101" pitchFamily="2" charset="-122"/>
                </a:rPr>
                <a:t>α-Tubulin</a:t>
              </a:r>
              <a:r>
                <a:rPr lang="zh-CN" altLang="zh-CN" dirty="0">
                  <a:effectLst/>
                </a:rPr>
                <a:t> </a:t>
              </a:r>
              <a:endParaRPr kumimoji="1"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9" name="框架 18">
            <a:extLst>
              <a:ext uri="{FF2B5EF4-FFF2-40B4-BE49-F238E27FC236}">
                <a16:creationId xmlns:a16="http://schemas.microsoft.com/office/drawing/2014/main" id="{57E76462-61C5-94C2-3C0F-1840B09DAFA1}"/>
              </a:ext>
            </a:extLst>
          </p:cNvPr>
          <p:cNvSpPr/>
          <p:nvPr/>
        </p:nvSpPr>
        <p:spPr>
          <a:xfrm>
            <a:off x="6816070" y="2058614"/>
            <a:ext cx="4484318" cy="554369"/>
          </a:xfrm>
          <a:prstGeom prst="fram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solidFill>
                <a:schemeClr val="tx1"/>
              </a:solidFill>
            </a:endParaRPr>
          </a:p>
        </p:txBody>
      </p:sp>
      <p:grpSp>
        <p:nvGrpSpPr>
          <p:cNvPr id="21" name="组合 20">
            <a:extLst>
              <a:ext uri="{FF2B5EF4-FFF2-40B4-BE49-F238E27FC236}">
                <a16:creationId xmlns:a16="http://schemas.microsoft.com/office/drawing/2014/main" id="{099FA8C2-8842-CC77-5632-DE58D33DBA6B}"/>
              </a:ext>
            </a:extLst>
          </p:cNvPr>
          <p:cNvGrpSpPr/>
          <p:nvPr/>
        </p:nvGrpSpPr>
        <p:grpSpPr>
          <a:xfrm>
            <a:off x="6408585" y="3561438"/>
            <a:ext cx="4629059" cy="3209807"/>
            <a:chOff x="6408585" y="3561438"/>
            <a:chExt cx="4629059" cy="3209807"/>
          </a:xfrm>
        </p:grpSpPr>
        <p:grpSp>
          <p:nvGrpSpPr>
            <p:cNvPr id="18" name="组合 17">
              <a:extLst>
                <a:ext uri="{FF2B5EF4-FFF2-40B4-BE49-F238E27FC236}">
                  <a16:creationId xmlns:a16="http://schemas.microsoft.com/office/drawing/2014/main" id="{A427C042-EC92-D545-0860-ACC5A3FCCCF7}"/>
                </a:ext>
              </a:extLst>
            </p:cNvPr>
            <p:cNvGrpSpPr/>
            <p:nvPr/>
          </p:nvGrpSpPr>
          <p:grpSpPr>
            <a:xfrm>
              <a:off x="6408585" y="3561438"/>
              <a:ext cx="4629059" cy="3209807"/>
              <a:chOff x="6408585" y="3561438"/>
              <a:chExt cx="4629059" cy="3209807"/>
            </a:xfrm>
          </p:grpSpPr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1609ED47-ABF8-885A-EC3E-1B788FC403BC}"/>
                  </a:ext>
                </a:extLst>
              </p:cNvPr>
              <p:cNvSpPr txBox="1"/>
              <p:nvPr/>
            </p:nvSpPr>
            <p:spPr>
              <a:xfrm>
                <a:off x="6408585" y="3561438"/>
                <a:ext cx="87716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800" kern="0" dirty="0">
                    <a:effectLst/>
                    <a:latin typeface="Arial" panose="020B0604020202020204" pitchFamily="34" charset="0"/>
                    <a:ea typeface="宋体" panose="02010600030101010101" pitchFamily="2" charset="-122"/>
                  </a:rPr>
                  <a:t>4-HNE</a:t>
                </a:r>
                <a:endParaRPr kumimoji="1"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4" name="图片 3">
                <a:extLst>
                  <a:ext uri="{FF2B5EF4-FFF2-40B4-BE49-F238E27FC236}">
                    <a16:creationId xmlns:a16="http://schemas.microsoft.com/office/drawing/2014/main" id="{D71C3E90-5AA9-34D9-D303-3488D9B6984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6689635" y="3942010"/>
                <a:ext cx="4348009" cy="2829235"/>
              </a:xfrm>
              <a:prstGeom prst="rect">
                <a:avLst/>
              </a:prstGeom>
            </p:spPr>
          </p:pic>
        </p:grpSp>
        <p:sp>
          <p:nvSpPr>
            <p:cNvPr id="20" name="框架 19">
              <a:extLst>
                <a:ext uri="{FF2B5EF4-FFF2-40B4-BE49-F238E27FC236}">
                  <a16:creationId xmlns:a16="http://schemas.microsoft.com/office/drawing/2014/main" id="{993811EA-F72C-6007-F16C-63EB8AA64C5D}"/>
                </a:ext>
              </a:extLst>
            </p:cNvPr>
            <p:cNvSpPr/>
            <p:nvPr/>
          </p:nvSpPr>
          <p:spPr>
            <a:xfrm>
              <a:off x="6689635" y="5284905"/>
              <a:ext cx="4040278" cy="773342"/>
            </a:xfrm>
            <a:prstGeom prst="fram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>
                <a:solidFill>
                  <a:schemeClr val="tx1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286074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70C43ADC-05FC-E746-358D-6D6FF3E7F2B8}"/>
              </a:ext>
            </a:extLst>
          </p:cNvPr>
          <p:cNvSpPr txBox="1"/>
          <p:nvPr/>
        </p:nvSpPr>
        <p:spPr>
          <a:xfrm>
            <a:off x="330869" y="248471"/>
            <a:ext cx="610001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" altLang="zh-CN" b="1" dirty="0"/>
              <a:t>Full unedited blot for Figure 6A</a:t>
            </a:r>
            <a:endParaRPr kumimoji="1"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" name="组合 12">
            <a:extLst>
              <a:ext uri="{FF2B5EF4-FFF2-40B4-BE49-F238E27FC236}">
                <a16:creationId xmlns:a16="http://schemas.microsoft.com/office/drawing/2014/main" id="{1CB17580-7FD4-46CE-9300-C042E5C10C61}"/>
              </a:ext>
            </a:extLst>
          </p:cNvPr>
          <p:cNvGrpSpPr/>
          <p:nvPr/>
        </p:nvGrpSpPr>
        <p:grpSpPr>
          <a:xfrm>
            <a:off x="445213" y="2098516"/>
            <a:ext cx="5300190" cy="3457575"/>
            <a:chOff x="657698" y="2300288"/>
            <a:chExt cx="5300190" cy="3457575"/>
          </a:xfrm>
        </p:grpSpPr>
        <p:grpSp>
          <p:nvGrpSpPr>
            <p:cNvPr id="10" name="组合 9">
              <a:extLst>
                <a:ext uri="{FF2B5EF4-FFF2-40B4-BE49-F238E27FC236}">
                  <a16:creationId xmlns:a16="http://schemas.microsoft.com/office/drawing/2014/main" id="{250BF209-10C6-86E1-4FAC-F910B8AF3867}"/>
                </a:ext>
              </a:extLst>
            </p:cNvPr>
            <p:cNvGrpSpPr/>
            <p:nvPr/>
          </p:nvGrpSpPr>
          <p:grpSpPr>
            <a:xfrm>
              <a:off x="657698" y="2300288"/>
              <a:ext cx="5300190" cy="3457575"/>
              <a:chOff x="772165" y="1758819"/>
              <a:chExt cx="5300190" cy="3457575"/>
            </a:xfrm>
          </p:grpSpPr>
          <p:pic>
            <p:nvPicPr>
              <p:cNvPr id="7" name="图片 6">
                <a:extLst>
                  <a:ext uri="{FF2B5EF4-FFF2-40B4-BE49-F238E27FC236}">
                    <a16:creationId xmlns:a16="http://schemas.microsoft.com/office/drawing/2014/main" id="{DC2B0A9B-6E1D-512E-0792-0D02280CD80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772165" y="1758819"/>
                <a:ext cx="5300190" cy="3457575"/>
              </a:xfrm>
              <a:prstGeom prst="rect">
                <a:avLst/>
              </a:prstGeom>
            </p:spPr>
          </p:pic>
          <p:sp>
            <p:nvSpPr>
              <p:cNvPr id="8" name="框架 7">
                <a:extLst>
                  <a:ext uri="{FF2B5EF4-FFF2-40B4-BE49-F238E27FC236}">
                    <a16:creationId xmlns:a16="http://schemas.microsoft.com/office/drawing/2014/main" id="{3A59E297-319C-0FD4-B16B-AE26D2EDD249}"/>
                  </a:ext>
                </a:extLst>
              </p:cNvPr>
              <p:cNvSpPr/>
              <p:nvPr/>
            </p:nvSpPr>
            <p:spPr>
              <a:xfrm>
                <a:off x="1576136" y="3285835"/>
                <a:ext cx="2261937" cy="554369"/>
              </a:xfrm>
              <a:prstGeom prst="fram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CN" alt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B5E47ED4-D726-530A-A942-6D599EE1781F}"/>
                  </a:ext>
                </a:extLst>
              </p:cNvPr>
              <p:cNvSpPr txBox="1"/>
              <p:nvPr/>
            </p:nvSpPr>
            <p:spPr>
              <a:xfrm>
                <a:off x="914401" y="3593983"/>
                <a:ext cx="58862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70 </a:t>
                </a:r>
                <a:r>
                  <a:rPr kumimoji="1" lang="en-US" altLang="zh-CN" sz="1000" dirty="0" err="1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kumimoji="1" lang="zh-CN" altLang="en-US" sz="1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783BFBBC-E630-D0B4-FDF2-B80658D3CDAA}"/>
                </a:ext>
              </a:extLst>
            </p:cNvPr>
            <p:cNvSpPr txBox="1"/>
            <p:nvPr/>
          </p:nvSpPr>
          <p:spPr>
            <a:xfrm>
              <a:off x="799934" y="3581083"/>
              <a:ext cx="65915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 </a:t>
              </a:r>
              <a:r>
                <a:rPr kumimoji="1" lang="en-US" altLang="zh-CN" sz="10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kumimoji="1" lang="zh-CN" alt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" name="文本框 13">
            <a:extLst>
              <a:ext uri="{FF2B5EF4-FFF2-40B4-BE49-F238E27FC236}">
                <a16:creationId xmlns:a16="http://schemas.microsoft.com/office/drawing/2014/main" id="{9AC48AC9-04AC-60E9-3C31-92FB3E0B4049}"/>
              </a:ext>
            </a:extLst>
          </p:cNvPr>
          <p:cNvSpPr txBox="1"/>
          <p:nvPr/>
        </p:nvSpPr>
        <p:spPr>
          <a:xfrm>
            <a:off x="587449" y="1575110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800" kern="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ACSL4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9" name="组合 18">
            <a:extLst>
              <a:ext uri="{FF2B5EF4-FFF2-40B4-BE49-F238E27FC236}">
                <a16:creationId xmlns:a16="http://schemas.microsoft.com/office/drawing/2014/main" id="{4C059E9C-8184-79CD-6822-B6BC3857BD59}"/>
              </a:ext>
            </a:extLst>
          </p:cNvPr>
          <p:cNvGrpSpPr/>
          <p:nvPr/>
        </p:nvGrpSpPr>
        <p:grpSpPr>
          <a:xfrm>
            <a:off x="6330507" y="467295"/>
            <a:ext cx="5326302" cy="3096947"/>
            <a:chOff x="6404767" y="730357"/>
            <a:chExt cx="5326302" cy="3096947"/>
          </a:xfrm>
        </p:grpSpPr>
        <p:pic>
          <p:nvPicPr>
            <p:cNvPr id="15" name="图片 14">
              <a:extLst>
                <a:ext uri="{FF2B5EF4-FFF2-40B4-BE49-F238E27FC236}">
                  <a16:creationId xmlns:a16="http://schemas.microsoft.com/office/drawing/2014/main" id="{3E58FF1B-997A-554F-9680-707AB567F48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430879" y="730357"/>
              <a:ext cx="5300190" cy="3096947"/>
            </a:xfrm>
            <a:prstGeom prst="rect">
              <a:avLst/>
            </a:prstGeom>
          </p:spPr>
        </p:pic>
        <p:sp>
          <p:nvSpPr>
            <p:cNvPr id="16" name="框架 15">
              <a:extLst>
                <a:ext uri="{FF2B5EF4-FFF2-40B4-BE49-F238E27FC236}">
                  <a16:creationId xmlns:a16="http://schemas.microsoft.com/office/drawing/2014/main" id="{36D56482-51FA-D210-8593-9F1388947CC3}"/>
                </a:ext>
              </a:extLst>
            </p:cNvPr>
            <p:cNvSpPr/>
            <p:nvPr/>
          </p:nvSpPr>
          <p:spPr>
            <a:xfrm>
              <a:off x="7145159" y="2420619"/>
              <a:ext cx="2261937" cy="554369"/>
            </a:xfrm>
            <a:prstGeom prst="fram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>
                <a:solidFill>
                  <a:schemeClr val="tx1"/>
                </a:solidFill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2F438174-CD4E-683E-CB4F-3179B2D52B29}"/>
                </a:ext>
              </a:extLst>
            </p:cNvPr>
            <p:cNvSpPr txBox="1"/>
            <p:nvPr/>
          </p:nvSpPr>
          <p:spPr>
            <a:xfrm>
              <a:off x="6404767" y="2543353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0 </a:t>
              </a:r>
              <a:r>
                <a:rPr kumimoji="1" lang="en-US" altLang="zh-CN" sz="10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kumimoji="1" lang="zh-CN" alt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9FC71E0E-F1B9-8C31-F1FD-5ED2B31153E5}"/>
                </a:ext>
              </a:extLst>
            </p:cNvPr>
            <p:cNvSpPr txBox="1"/>
            <p:nvPr/>
          </p:nvSpPr>
          <p:spPr>
            <a:xfrm>
              <a:off x="6404768" y="2229975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5 </a:t>
              </a:r>
              <a:r>
                <a:rPr kumimoji="1" lang="en-US" altLang="zh-CN" sz="10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kumimoji="1" lang="zh-CN" alt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0" name="文本框 13">
            <a:extLst>
              <a:ext uri="{FF2B5EF4-FFF2-40B4-BE49-F238E27FC236}">
                <a16:creationId xmlns:a16="http://schemas.microsoft.com/office/drawing/2014/main" id="{372D6DE2-0724-4A45-56C5-BD9210B4FB94}"/>
              </a:ext>
            </a:extLst>
          </p:cNvPr>
          <p:cNvSpPr txBox="1"/>
          <p:nvPr/>
        </p:nvSpPr>
        <p:spPr>
          <a:xfrm>
            <a:off x="6330507" y="97963"/>
            <a:ext cx="1072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800" kern="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C/EBPα</a:t>
            </a:r>
            <a:r>
              <a:rPr lang="zh-CN" altLang="zh-CN" dirty="0">
                <a:effectLst/>
              </a:rPr>
              <a:t> 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5" name="组合 24">
            <a:extLst>
              <a:ext uri="{FF2B5EF4-FFF2-40B4-BE49-F238E27FC236}">
                <a16:creationId xmlns:a16="http://schemas.microsoft.com/office/drawing/2014/main" id="{66E0C8F5-B499-7160-1CC2-D9C7C05145DF}"/>
              </a:ext>
            </a:extLst>
          </p:cNvPr>
          <p:cNvGrpSpPr/>
          <p:nvPr/>
        </p:nvGrpSpPr>
        <p:grpSpPr>
          <a:xfrm>
            <a:off x="6470906" y="4056790"/>
            <a:ext cx="4439170" cy="2654638"/>
            <a:chOff x="6470906" y="4056790"/>
            <a:chExt cx="4439170" cy="2654638"/>
          </a:xfrm>
        </p:grpSpPr>
        <p:pic>
          <p:nvPicPr>
            <p:cNvPr id="21" name="图片 20">
              <a:extLst>
                <a:ext uri="{FF2B5EF4-FFF2-40B4-BE49-F238E27FC236}">
                  <a16:creationId xmlns:a16="http://schemas.microsoft.com/office/drawing/2014/main" id="{91E67484-7F6E-3919-89BD-0176A494C19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470906" y="4056790"/>
              <a:ext cx="4439170" cy="2654638"/>
            </a:xfrm>
            <a:prstGeom prst="rect">
              <a:avLst/>
            </a:prstGeom>
          </p:spPr>
        </p:pic>
        <p:sp>
          <p:nvSpPr>
            <p:cNvPr id="22" name="框架 21">
              <a:extLst>
                <a:ext uri="{FF2B5EF4-FFF2-40B4-BE49-F238E27FC236}">
                  <a16:creationId xmlns:a16="http://schemas.microsoft.com/office/drawing/2014/main" id="{5511B6A8-231F-D8C5-AB4A-90D4C1AC5357}"/>
                </a:ext>
              </a:extLst>
            </p:cNvPr>
            <p:cNvSpPr/>
            <p:nvPr/>
          </p:nvSpPr>
          <p:spPr>
            <a:xfrm>
              <a:off x="7222668" y="5043550"/>
              <a:ext cx="1678445" cy="368955"/>
            </a:xfrm>
            <a:prstGeom prst="fram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>
                <a:solidFill>
                  <a:schemeClr val="tx1"/>
                </a:solidFill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956D7828-612A-8E57-767D-E0E9A782D206}"/>
                </a:ext>
              </a:extLst>
            </p:cNvPr>
            <p:cNvSpPr txBox="1"/>
            <p:nvPr/>
          </p:nvSpPr>
          <p:spPr>
            <a:xfrm>
              <a:off x="6482276" y="5166284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5 </a:t>
              </a:r>
              <a:r>
                <a:rPr kumimoji="1" lang="en-US" altLang="zh-CN" sz="10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kumimoji="1" lang="zh-CN" alt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A5B302AA-7CEB-2015-44C2-39DC513C4A77}"/>
                </a:ext>
              </a:extLst>
            </p:cNvPr>
            <p:cNvSpPr txBox="1"/>
            <p:nvPr/>
          </p:nvSpPr>
          <p:spPr>
            <a:xfrm>
              <a:off x="6482277" y="4852906"/>
              <a:ext cx="5886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0 </a:t>
              </a:r>
              <a:r>
                <a:rPr kumimoji="1" lang="en-US" altLang="zh-CN" sz="1000" dirty="0" err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kumimoji="1" lang="zh-CN" alt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6" name="文本框 25">
            <a:extLst>
              <a:ext uri="{FF2B5EF4-FFF2-40B4-BE49-F238E27FC236}">
                <a16:creationId xmlns:a16="http://schemas.microsoft.com/office/drawing/2014/main" id="{5624819F-C581-F5E8-217A-FBEEED47E65F}"/>
              </a:ext>
            </a:extLst>
          </p:cNvPr>
          <p:cNvSpPr txBox="1"/>
          <p:nvPr/>
        </p:nvSpPr>
        <p:spPr>
          <a:xfrm>
            <a:off x="6304244" y="3636754"/>
            <a:ext cx="1213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800" kern="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α-Tubulin</a:t>
            </a:r>
            <a:r>
              <a:rPr lang="zh-CN" altLang="zh-CN" dirty="0">
                <a:effectLst/>
              </a:rPr>
              <a:t> 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5685541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2F99CAF7-6344-3A0E-DABE-DA20DC996B6F}"/>
              </a:ext>
            </a:extLst>
          </p:cNvPr>
          <p:cNvSpPr txBox="1"/>
          <p:nvPr/>
        </p:nvSpPr>
        <p:spPr>
          <a:xfrm>
            <a:off x="300624" y="150312"/>
            <a:ext cx="34884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" altLang="zh-CN" b="1" dirty="0"/>
              <a:t>Full unedited blot for Figure 9G</a:t>
            </a:r>
            <a:endParaRPr kumimoji="1"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1609ED47-ABF8-885A-EC3E-1B788FC403BC}"/>
              </a:ext>
            </a:extLst>
          </p:cNvPr>
          <p:cNvSpPr txBox="1"/>
          <p:nvPr/>
        </p:nvSpPr>
        <p:spPr>
          <a:xfrm>
            <a:off x="6762676" y="1096980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800" kern="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GPX4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" name="组合 14">
            <a:extLst>
              <a:ext uri="{FF2B5EF4-FFF2-40B4-BE49-F238E27FC236}">
                <a16:creationId xmlns:a16="http://schemas.microsoft.com/office/drawing/2014/main" id="{E25CA064-328D-A652-CFDE-914F7BFB71F9}"/>
              </a:ext>
            </a:extLst>
          </p:cNvPr>
          <p:cNvGrpSpPr/>
          <p:nvPr/>
        </p:nvGrpSpPr>
        <p:grpSpPr>
          <a:xfrm>
            <a:off x="6530238" y="1544123"/>
            <a:ext cx="4983670" cy="4055036"/>
            <a:chOff x="6342348" y="1456441"/>
            <a:chExt cx="4983670" cy="4055036"/>
          </a:xfrm>
        </p:grpSpPr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CEA68C08-1F1D-FE6E-335D-2C274A0725E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342348" y="1456441"/>
              <a:ext cx="4983670" cy="4055036"/>
            </a:xfrm>
            <a:prstGeom prst="rect">
              <a:avLst/>
            </a:prstGeom>
          </p:spPr>
        </p:pic>
        <p:sp>
          <p:nvSpPr>
            <p:cNvPr id="14" name="框架 13">
              <a:extLst>
                <a:ext uri="{FF2B5EF4-FFF2-40B4-BE49-F238E27FC236}">
                  <a16:creationId xmlns:a16="http://schemas.microsoft.com/office/drawing/2014/main" id="{1D59B240-C4ED-F986-9D23-C08B1151A44D}"/>
                </a:ext>
              </a:extLst>
            </p:cNvPr>
            <p:cNvSpPr/>
            <p:nvPr/>
          </p:nvSpPr>
          <p:spPr>
            <a:xfrm>
              <a:off x="6733971" y="4183694"/>
              <a:ext cx="4501876" cy="518878"/>
            </a:xfrm>
            <a:prstGeom prst="fram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>
                <a:solidFill>
                  <a:schemeClr val="tx1"/>
                </a:solidFill>
              </a:endParaRPr>
            </a:p>
          </p:txBody>
        </p:sp>
      </p:grpSp>
      <p:grpSp>
        <p:nvGrpSpPr>
          <p:cNvPr id="19" name="组合 18">
            <a:extLst>
              <a:ext uri="{FF2B5EF4-FFF2-40B4-BE49-F238E27FC236}">
                <a16:creationId xmlns:a16="http://schemas.microsoft.com/office/drawing/2014/main" id="{318E27C5-1048-C9FC-BC5E-BAB2F1CEC2AB}"/>
              </a:ext>
            </a:extLst>
          </p:cNvPr>
          <p:cNvGrpSpPr/>
          <p:nvPr/>
        </p:nvGrpSpPr>
        <p:grpSpPr>
          <a:xfrm>
            <a:off x="-73152" y="1544123"/>
            <a:ext cx="6407579" cy="4055036"/>
            <a:chOff x="-73152" y="1544123"/>
            <a:chExt cx="6407579" cy="4055036"/>
          </a:xfrm>
        </p:grpSpPr>
        <p:grpSp>
          <p:nvGrpSpPr>
            <p:cNvPr id="17" name="组合 16">
              <a:extLst>
                <a:ext uri="{FF2B5EF4-FFF2-40B4-BE49-F238E27FC236}">
                  <a16:creationId xmlns:a16="http://schemas.microsoft.com/office/drawing/2014/main" id="{AAC91BAB-11F0-9C07-7A6F-11F3A7B3BB45}"/>
                </a:ext>
              </a:extLst>
            </p:cNvPr>
            <p:cNvGrpSpPr/>
            <p:nvPr/>
          </p:nvGrpSpPr>
          <p:grpSpPr>
            <a:xfrm>
              <a:off x="-73152" y="1544123"/>
              <a:ext cx="6407579" cy="4055036"/>
              <a:chOff x="-73152" y="1544123"/>
              <a:chExt cx="6407579" cy="4055036"/>
            </a:xfrm>
          </p:grpSpPr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7B0B83D0-E29D-7DF6-4129-93A02F4B1B84}"/>
                  </a:ext>
                </a:extLst>
              </p:cNvPr>
              <p:cNvSpPr txBox="1"/>
              <p:nvPr/>
            </p:nvSpPr>
            <p:spPr>
              <a:xfrm>
                <a:off x="-73152" y="2508429"/>
                <a:ext cx="13260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800" kern="0" dirty="0">
                    <a:effectLst/>
                    <a:latin typeface="Arial" panose="020B0604020202020204" pitchFamily="34" charset="0"/>
                    <a:ea typeface="宋体" panose="02010600030101010101" pitchFamily="2" charset="-122"/>
                  </a:rPr>
                  <a:t>Fibronectin</a:t>
                </a:r>
                <a:endParaRPr kumimoji="1"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0" name="图片 9">
                <a:extLst>
                  <a:ext uri="{FF2B5EF4-FFF2-40B4-BE49-F238E27FC236}">
                    <a16:creationId xmlns:a16="http://schemas.microsoft.com/office/drawing/2014/main" id="{F4F4143C-4CFF-82F9-6D79-5D0B0A0430D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350757" y="1544123"/>
                <a:ext cx="4983670" cy="4055036"/>
              </a:xfrm>
              <a:prstGeom prst="rect">
                <a:avLst/>
              </a:prstGeom>
            </p:spPr>
          </p:pic>
          <p:sp>
            <p:nvSpPr>
              <p:cNvPr id="13" name="框架 12">
                <a:extLst>
                  <a:ext uri="{FF2B5EF4-FFF2-40B4-BE49-F238E27FC236}">
                    <a16:creationId xmlns:a16="http://schemas.microsoft.com/office/drawing/2014/main" id="{7F5AC973-1FC4-2AF5-637D-3F0E3DC5FE84}"/>
                  </a:ext>
                </a:extLst>
              </p:cNvPr>
              <p:cNvSpPr/>
              <p:nvPr/>
            </p:nvSpPr>
            <p:spPr>
              <a:xfrm>
                <a:off x="1611682" y="2508429"/>
                <a:ext cx="4484318" cy="400833"/>
              </a:xfrm>
              <a:prstGeom prst="fram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CN" alt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16" name="框架 15">
                <a:extLst>
                  <a:ext uri="{FF2B5EF4-FFF2-40B4-BE49-F238E27FC236}">
                    <a16:creationId xmlns:a16="http://schemas.microsoft.com/office/drawing/2014/main" id="{485B1768-F57A-FBB5-22B0-396F7F85DCE6}"/>
                  </a:ext>
                </a:extLst>
              </p:cNvPr>
              <p:cNvSpPr/>
              <p:nvPr/>
            </p:nvSpPr>
            <p:spPr>
              <a:xfrm>
                <a:off x="1611682" y="3964488"/>
                <a:ext cx="4484318" cy="400833"/>
              </a:xfrm>
              <a:prstGeom prst="fram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CN" altLang="en-US">
                  <a:solidFill>
                    <a:schemeClr val="tx1"/>
                  </a:solidFill>
                </a:endParaRPr>
              </a:p>
            </p:txBody>
          </p:sp>
        </p:grp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8EE28C3C-C21C-A4FC-EA50-B69E3956A0A4}"/>
                </a:ext>
              </a:extLst>
            </p:cNvPr>
            <p:cNvSpPr txBox="1"/>
            <p:nvPr/>
          </p:nvSpPr>
          <p:spPr>
            <a:xfrm>
              <a:off x="39058" y="3980240"/>
              <a:ext cx="12137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800" kern="0" dirty="0">
                  <a:effectLst/>
                  <a:latin typeface="Arial" panose="020B0604020202020204" pitchFamily="34" charset="0"/>
                  <a:ea typeface="宋体" panose="02010600030101010101" pitchFamily="2" charset="-122"/>
                </a:rPr>
                <a:t>α-Tubulin</a:t>
              </a:r>
              <a:r>
                <a:rPr lang="zh-CN" altLang="zh-CN" dirty="0">
                  <a:effectLst/>
                </a:rPr>
                <a:t> </a:t>
              </a:r>
              <a:endParaRPr kumimoji="1"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1134277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59</Words>
  <Application>Microsoft Macintosh PowerPoint</Application>
  <PresentationFormat>宽屏</PresentationFormat>
  <Paragraphs>24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9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iru xia</dc:creator>
  <cp:lastModifiedBy>ziru xia</cp:lastModifiedBy>
  <cp:revision>30</cp:revision>
  <dcterms:created xsi:type="dcterms:W3CDTF">2023-10-13T01:04:08Z</dcterms:created>
  <dcterms:modified xsi:type="dcterms:W3CDTF">2024-01-29T04:00:04Z</dcterms:modified>
</cp:coreProperties>
</file>